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88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521"/>
    <p:restoredTop sz="95788"/>
  </p:normalViewPr>
  <p:slideViewPr>
    <p:cSldViewPr snapToGrid="0">
      <p:cViewPr varScale="1">
        <p:scale>
          <a:sx n="85" d="100"/>
          <a:sy n="85" d="100"/>
        </p:scale>
        <p:origin x="282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628770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644468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04425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981082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293305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792829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6991068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186978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949923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10615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527247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12876-F229-8748-A532-FF65F1587E5C}" type="datetimeFigureOut">
              <a:rPr lang="en-SE" smtClean="0"/>
              <a:t>2024-04-23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CC0686-37DF-6A48-BE92-1E26C910905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875637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A0E533C-131D-D7ED-3730-80B39F5D2A44}"/>
              </a:ext>
            </a:extLst>
          </p:cNvPr>
          <p:cNvGrpSpPr/>
          <p:nvPr/>
        </p:nvGrpSpPr>
        <p:grpSpPr>
          <a:xfrm>
            <a:off x="1886716" y="1954106"/>
            <a:ext cx="2347024" cy="2599667"/>
            <a:chOff x="720227" y="1157757"/>
            <a:chExt cx="2040854" cy="2399564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63273AB4-9F09-80BB-8972-7794344A6F82}"/>
                </a:ext>
              </a:extLst>
            </p:cNvPr>
            <p:cNvGrpSpPr/>
            <p:nvPr/>
          </p:nvGrpSpPr>
          <p:grpSpPr>
            <a:xfrm>
              <a:off x="758077" y="1157757"/>
              <a:ext cx="2003004" cy="965121"/>
              <a:chOff x="702713" y="797123"/>
              <a:chExt cx="2003004" cy="965121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09188CF4-166E-D460-1921-6AA827ECADAD}"/>
                  </a:ext>
                </a:extLst>
              </p:cNvPr>
              <p:cNvGrpSpPr/>
              <p:nvPr/>
            </p:nvGrpSpPr>
            <p:grpSpPr>
              <a:xfrm>
                <a:off x="850110" y="1166454"/>
                <a:ext cx="1855607" cy="595790"/>
                <a:chOff x="4277294" y="2267152"/>
                <a:chExt cx="2848715" cy="738561"/>
              </a:xfrm>
            </p:grpSpPr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156C9B9D-DC57-7C9F-251D-0A0179D9E477}"/>
                    </a:ext>
                  </a:extLst>
                </p:cNvPr>
                <p:cNvGrpSpPr/>
                <p:nvPr/>
              </p:nvGrpSpPr>
              <p:grpSpPr>
                <a:xfrm>
                  <a:off x="4277294" y="2267153"/>
                  <a:ext cx="2848715" cy="738560"/>
                  <a:chOff x="4402816" y="2267190"/>
                  <a:chExt cx="2848715" cy="738560"/>
                </a:xfrm>
              </p:grpSpPr>
              <p:sp>
                <p:nvSpPr>
                  <p:cNvPr id="17" name="Rectangle 16">
                    <a:extLst>
                      <a:ext uri="{FF2B5EF4-FFF2-40B4-BE49-F238E27FC236}">
                        <a16:creationId xmlns:a16="http://schemas.microsoft.com/office/drawing/2014/main" id="{F25EE60E-F0E8-27F6-2E96-505790321E95}"/>
                      </a:ext>
                    </a:extLst>
                  </p:cNvPr>
                  <p:cNvSpPr/>
                  <p:nvPr/>
                </p:nvSpPr>
                <p:spPr>
                  <a:xfrm>
                    <a:off x="4402816" y="2588253"/>
                    <a:ext cx="1284158" cy="417497"/>
                  </a:xfrm>
                  <a:prstGeom prst="rect">
                    <a:avLst/>
                  </a:prstGeom>
                  <a:noFill/>
                  <a:ln w="12700"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SE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  <a:r>
                      <a:rPr lang="en-SE" sz="7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</a:t>
                    </a:r>
                    <a:r>
                      <a:rPr lang="en-SE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MSA + (APN)</a:t>
                    </a:r>
                  </a:p>
                  <a:p>
                    <a:pPr algn="ctr"/>
                    <a:r>
                      <a:rPr lang="en-GB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= 32</a:t>
                    </a:r>
                    <a:endParaRPr lang="en-SE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" name="Rectangle 17">
                    <a:extLst>
                      <a:ext uri="{FF2B5EF4-FFF2-40B4-BE49-F238E27FC236}">
                        <a16:creationId xmlns:a16="http://schemas.microsoft.com/office/drawing/2014/main" id="{2A2DC843-0EB1-CD70-58AA-99FDB72EA84C}"/>
                      </a:ext>
                    </a:extLst>
                  </p:cNvPr>
                  <p:cNvSpPr/>
                  <p:nvPr/>
                </p:nvSpPr>
                <p:spPr>
                  <a:xfrm>
                    <a:off x="5967372" y="2586680"/>
                    <a:ext cx="1284159" cy="384572"/>
                  </a:xfrm>
                  <a:prstGeom prst="rect">
                    <a:avLst/>
                  </a:prstGeom>
                  <a:noFill/>
                  <a:ln w="12700">
                    <a:solidFill>
                      <a:schemeClr val="accent1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SE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  <a:r>
                      <a:rPr lang="en-SE" sz="7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</a:t>
                    </a:r>
                    <a:r>
                      <a:rPr lang="en-SE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MSA - (no APN)</a:t>
                    </a:r>
                  </a:p>
                  <a:p>
                    <a:pPr algn="ctr"/>
                    <a:r>
                      <a:rPr lang="en-GB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= 24</a:t>
                    </a:r>
                    <a:endParaRPr lang="en-SE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9" name="Straight Arrow Connector 18">
                    <a:extLst>
                      <a:ext uri="{FF2B5EF4-FFF2-40B4-BE49-F238E27FC236}">
                        <a16:creationId xmlns:a16="http://schemas.microsoft.com/office/drawing/2014/main" id="{7EAE1C87-4C02-2401-345E-27851F669A39}"/>
                      </a:ext>
                    </a:extLst>
                  </p:cNvPr>
                  <p:cNvCxnSpPr>
                    <a:cxnSpLocks/>
                    <a:stCxn id="13" idx="2"/>
                    <a:endCxn id="18" idx="0"/>
                  </p:cNvCxnSpPr>
                  <p:nvPr/>
                </p:nvCxnSpPr>
                <p:spPr>
                  <a:xfrm>
                    <a:off x="5047165" y="2267190"/>
                    <a:ext cx="1562287" cy="31949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6" name="Straight Arrow Connector 15">
                  <a:extLst>
                    <a:ext uri="{FF2B5EF4-FFF2-40B4-BE49-F238E27FC236}">
                      <a16:creationId xmlns:a16="http://schemas.microsoft.com/office/drawing/2014/main" id="{B5E8ABDA-768C-D615-B373-4539B913873B}"/>
                    </a:ext>
                  </a:extLst>
                </p:cNvPr>
                <p:cNvCxnSpPr>
                  <a:cxnSpLocks/>
                  <a:stCxn id="13" idx="2"/>
                  <a:endCxn id="17" idx="0"/>
                </p:cNvCxnSpPr>
                <p:nvPr/>
              </p:nvCxnSpPr>
              <p:spPr>
                <a:xfrm flipH="1">
                  <a:off x="4919373" y="2267152"/>
                  <a:ext cx="2269" cy="321065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D292E00C-F22A-2CEC-0A1E-6FD1890AF435}"/>
                  </a:ext>
                </a:extLst>
              </p:cNvPr>
              <p:cNvGrpSpPr/>
              <p:nvPr/>
            </p:nvGrpSpPr>
            <p:grpSpPr>
              <a:xfrm>
                <a:off x="702713" y="797123"/>
                <a:ext cx="1215880" cy="783778"/>
                <a:chOff x="830037" y="449472"/>
                <a:chExt cx="1215880" cy="783778"/>
              </a:xfrm>
            </p:grpSpPr>
            <p:sp>
              <p:nvSpPr>
                <p:cNvPr id="13" name="Rectangle 12">
                  <a:extLst>
                    <a:ext uri="{FF2B5EF4-FFF2-40B4-BE49-F238E27FC236}">
                      <a16:creationId xmlns:a16="http://schemas.microsoft.com/office/drawing/2014/main" id="{9309D20F-DA3F-1AB3-C7B8-9ECDE6E9FF35}"/>
                    </a:ext>
                  </a:extLst>
                </p:cNvPr>
                <p:cNvSpPr/>
                <p:nvPr/>
              </p:nvSpPr>
              <p:spPr>
                <a:xfrm>
                  <a:off x="976977" y="449472"/>
                  <a:ext cx="840352" cy="36933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SE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r>
                    <a:rPr lang="en-SE" sz="700" baseline="300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t</a:t>
                  </a:r>
                  <a:r>
                    <a:rPr lang="en-SE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DMSA within 1 w  </a:t>
                  </a:r>
                </a:p>
                <a:p>
                  <a:pPr algn="ctr"/>
                  <a:r>
                    <a:rPr lang="en-GB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56</a:t>
                  </a:r>
                  <a:endParaRPr lang="en-SE" sz="7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C96F041C-D5D1-79AD-F620-C7C9E1BE2440}"/>
                    </a:ext>
                  </a:extLst>
                </p:cNvPr>
                <p:cNvSpPr/>
                <p:nvPr/>
              </p:nvSpPr>
              <p:spPr>
                <a:xfrm>
                  <a:off x="830037" y="923020"/>
                  <a:ext cx="1215880" cy="310230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7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6AA841F8-042F-C6CC-9DD0-B2DAF4A4EBAD}"/>
                </a:ext>
              </a:extLst>
            </p:cNvPr>
            <p:cNvGrpSpPr/>
            <p:nvPr/>
          </p:nvGrpSpPr>
          <p:grpSpPr>
            <a:xfrm>
              <a:off x="720227" y="2207709"/>
              <a:ext cx="2040854" cy="1349612"/>
              <a:chOff x="603553" y="2792647"/>
              <a:chExt cx="2040854" cy="1349612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4F808CF5-B2F3-DDB6-D6FE-1A69A2032065}"/>
                  </a:ext>
                </a:extLst>
              </p:cNvPr>
              <p:cNvGrpSpPr/>
              <p:nvPr/>
            </p:nvGrpSpPr>
            <p:grpSpPr>
              <a:xfrm>
                <a:off x="788343" y="2792647"/>
                <a:ext cx="1856064" cy="598375"/>
                <a:chOff x="976354" y="310847"/>
                <a:chExt cx="1856064" cy="598375"/>
              </a:xfrm>
            </p:grpSpPr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id="{6C178E15-517A-3997-4FAC-7F957E166565}"/>
                    </a:ext>
                  </a:extLst>
                </p:cNvPr>
                <p:cNvSpPr/>
                <p:nvPr/>
              </p:nvSpPr>
              <p:spPr>
                <a:xfrm>
                  <a:off x="976354" y="601888"/>
                  <a:ext cx="836462" cy="307334"/>
                </a:xfrm>
                <a:prstGeom prst="rect">
                  <a:avLst/>
                </a:prstGeom>
                <a:solidFill>
                  <a:srgbClr val="632523">
                    <a:alpha val="89020"/>
                  </a:srgbClr>
                </a:solidFill>
                <a:ln w="9525">
                  <a:solidFill>
                    <a:schemeClr val="accent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SE" sz="7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nal scarring</a:t>
                  </a:r>
                </a:p>
                <a:p>
                  <a:pPr algn="ctr"/>
                  <a:r>
                    <a:rPr lang="en-GB" sz="7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7</a:t>
                  </a:r>
                  <a:endParaRPr lang="en-SE" sz="7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Rectangle 7">
                  <a:extLst>
                    <a:ext uri="{FF2B5EF4-FFF2-40B4-BE49-F238E27FC236}">
                      <a16:creationId xmlns:a16="http://schemas.microsoft.com/office/drawing/2014/main" id="{E5C41C0E-4E7E-6950-2BFD-510BF5D95D09}"/>
                    </a:ext>
                  </a:extLst>
                </p:cNvPr>
                <p:cNvSpPr/>
                <p:nvPr/>
              </p:nvSpPr>
              <p:spPr>
                <a:xfrm>
                  <a:off x="1995940" y="590772"/>
                  <a:ext cx="836478" cy="310230"/>
                </a:xfrm>
                <a:prstGeom prst="rect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SE" sz="7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solved APN </a:t>
                  </a:r>
                </a:p>
                <a:p>
                  <a:pPr algn="ctr"/>
                  <a:r>
                    <a:rPr lang="en-GB" sz="7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25</a:t>
                  </a:r>
                  <a:endParaRPr lang="en-SE" sz="7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" name="Straight Arrow Connector 8">
                  <a:extLst>
                    <a:ext uri="{FF2B5EF4-FFF2-40B4-BE49-F238E27FC236}">
                      <a16:creationId xmlns:a16="http://schemas.microsoft.com/office/drawing/2014/main" id="{4FA3F306-130F-A7B4-EDDC-10CC29677E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90820" y="310847"/>
                  <a:ext cx="0" cy="224813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Arrow Connector 9">
                  <a:extLst>
                    <a:ext uri="{FF2B5EF4-FFF2-40B4-BE49-F238E27FC236}">
                      <a16:creationId xmlns:a16="http://schemas.microsoft.com/office/drawing/2014/main" id="{8F13561D-FABD-28F5-DA51-856E3A13969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90065" y="310849"/>
                  <a:ext cx="1019128" cy="248667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2BD3B460-24BD-8BFC-36A5-8835467B2C7B}"/>
                  </a:ext>
                </a:extLst>
              </p:cNvPr>
              <p:cNvSpPr/>
              <p:nvPr/>
            </p:nvSpPr>
            <p:spPr>
              <a:xfrm>
                <a:off x="603553" y="3805468"/>
                <a:ext cx="1238837" cy="336791"/>
              </a:xfrm>
              <a:prstGeom prst="rect">
                <a:avLst/>
              </a:prstGeom>
              <a:noFill/>
              <a:ln w="952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 sz="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858967DF-3DA8-F0F7-EF88-BA0EE3D02F96}"/>
              </a:ext>
            </a:extLst>
          </p:cNvPr>
          <p:cNvSpPr txBox="1"/>
          <p:nvPr/>
        </p:nvSpPr>
        <p:spPr>
          <a:xfrm>
            <a:off x="0" y="67586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igure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8B87C73-F677-B15B-B3F2-A38F11955FD7}"/>
              </a:ext>
            </a:extLst>
          </p:cNvPr>
          <p:cNvSpPr txBox="1"/>
          <p:nvPr/>
        </p:nvSpPr>
        <p:spPr>
          <a:xfrm>
            <a:off x="1739079" y="16677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E5CB0223-165B-466F-9136-7A891ADFD3D0}"/>
              </a:ext>
            </a:extLst>
          </p:cNvPr>
          <p:cNvGrpSpPr/>
          <p:nvPr/>
        </p:nvGrpSpPr>
        <p:grpSpPr>
          <a:xfrm>
            <a:off x="2099228" y="4231576"/>
            <a:ext cx="1893517" cy="2241304"/>
            <a:chOff x="826820" y="4233517"/>
            <a:chExt cx="1893517" cy="2241304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5298BCD8-CAD3-F066-2F0E-1D31A24CC6DB}"/>
                </a:ext>
              </a:extLst>
            </p:cNvPr>
            <p:cNvGrpSpPr/>
            <p:nvPr/>
          </p:nvGrpSpPr>
          <p:grpSpPr>
            <a:xfrm>
              <a:off x="826820" y="4477441"/>
              <a:ext cx="1840180" cy="1997380"/>
              <a:chOff x="231497" y="1258624"/>
              <a:chExt cx="2557474" cy="2743807"/>
            </a:xfrm>
          </p:grpSpPr>
          <p:pic>
            <p:nvPicPr>
              <p:cNvPr id="29" name="Picture 28" descr="Graphical user interface, application&#10;&#10;Description automatically generated">
                <a:extLst>
                  <a:ext uri="{FF2B5EF4-FFF2-40B4-BE49-F238E27FC236}">
                    <a16:creationId xmlns:a16="http://schemas.microsoft.com/office/drawing/2014/main" id="{D2CBCF47-50B3-D4DA-1CD6-69A23C14E0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4259" r="32953"/>
              <a:stretch/>
            </p:blipFill>
            <p:spPr>
              <a:xfrm>
                <a:off x="961535" y="1379269"/>
                <a:ext cx="1827436" cy="2623162"/>
              </a:xfrm>
              <a:prstGeom prst="rect">
                <a:avLst/>
              </a:prstGeom>
            </p:spPr>
          </p:pic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3E137503-B7CE-33D9-0E2E-6F72AC5150EF}"/>
                  </a:ext>
                </a:extLst>
              </p:cNvPr>
              <p:cNvGrpSpPr/>
              <p:nvPr/>
            </p:nvGrpSpPr>
            <p:grpSpPr>
              <a:xfrm>
                <a:off x="231497" y="1258624"/>
                <a:ext cx="670472" cy="2668362"/>
                <a:chOff x="57233" y="1584792"/>
                <a:chExt cx="670472" cy="2668362"/>
              </a:xfrm>
            </p:grpSpPr>
            <p:cxnSp>
              <p:nvCxnSpPr>
                <p:cNvPr id="31" name="Straight Arrow Connector 30">
                  <a:extLst>
                    <a:ext uri="{FF2B5EF4-FFF2-40B4-BE49-F238E27FC236}">
                      <a16:creationId xmlns:a16="http://schemas.microsoft.com/office/drawing/2014/main" id="{3F868A21-EACA-6BB5-B4D7-F080329AE5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63809" y="1664208"/>
                  <a:ext cx="0" cy="2588946"/>
                </a:xfrm>
                <a:prstGeom prst="straightConnector1">
                  <a:avLst/>
                </a:prstGeom>
                <a:ln w="38100">
                  <a:solidFill>
                    <a:schemeClr val="bg2">
                      <a:lumMod val="10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B17AE276-7D14-1CC9-46CB-3CBB35302EE4}"/>
                    </a:ext>
                  </a:extLst>
                </p:cNvPr>
                <p:cNvSpPr txBox="1"/>
                <p:nvPr/>
              </p:nvSpPr>
              <p:spPr>
                <a:xfrm rot="16200000">
                  <a:off x="-211665" y="1853690"/>
                  <a:ext cx="837220" cy="29942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Helvetica" pitchFamily="2" charset="0"/>
                    </a:rPr>
                    <a:t>O</a:t>
                  </a:r>
                  <a:r>
                    <a:rPr lang="en-SE" sz="800" dirty="0">
                      <a:latin typeface="Helvetica" pitchFamily="2" charset="0"/>
                    </a:rPr>
                    <a:t>dd ratio</a:t>
                  </a:r>
                </a:p>
              </p:txBody>
            </p:sp>
            <p:sp>
              <p:nvSpPr>
                <p:cNvPr id="33" name="Rectangle 32">
                  <a:extLst>
                    <a:ext uri="{FF2B5EF4-FFF2-40B4-BE49-F238E27FC236}">
                      <a16:creationId xmlns:a16="http://schemas.microsoft.com/office/drawing/2014/main" id="{F1E42785-E53C-6151-168E-2C5426E7F232}"/>
                    </a:ext>
                  </a:extLst>
                </p:cNvPr>
                <p:cNvSpPr/>
                <p:nvPr/>
              </p:nvSpPr>
              <p:spPr>
                <a:xfrm>
                  <a:off x="605831" y="1759445"/>
                  <a:ext cx="121874" cy="1754143"/>
                </a:xfrm>
                <a:prstGeom prst="rect">
                  <a:avLst/>
                </a:prstGeom>
                <a:solidFill>
                  <a:schemeClr val="accent2">
                    <a:lumMod val="50000"/>
                  </a:schemeClr>
                </a:solidFill>
                <a:ln>
                  <a:solidFill>
                    <a:schemeClr val="accent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800">
                    <a:latin typeface="Helvetica" pitchFamily="2" charset="0"/>
                  </a:endParaRPr>
                </a:p>
              </p:txBody>
            </p:sp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1813C15B-1F64-956D-7B60-6FF5ABD846B9}"/>
                    </a:ext>
                  </a:extLst>
                </p:cNvPr>
                <p:cNvSpPr/>
                <p:nvPr/>
              </p:nvSpPr>
              <p:spPr>
                <a:xfrm>
                  <a:off x="603132" y="3562453"/>
                  <a:ext cx="124573" cy="690701"/>
                </a:xfrm>
                <a:prstGeom prst="rect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>
                  <a:solidFill>
                    <a:schemeClr val="accent2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E" sz="800">
                    <a:latin typeface="Helvetica" pitchFamily="2" charset="0"/>
                  </a:endParaRP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83BC520A-DC4D-C442-823B-6E5A7AA1B99C}"/>
                    </a:ext>
                  </a:extLst>
                </p:cNvPr>
                <p:cNvSpPr txBox="1"/>
                <p:nvPr/>
              </p:nvSpPr>
              <p:spPr>
                <a:xfrm rot="16200000">
                  <a:off x="148935" y="2427089"/>
                  <a:ext cx="665460" cy="29942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SE" sz="800" dirty="0">
                      <a:latin typeface="Helvetica" pitchFamily="2" charset="0"/>
                    </a:rPr>
                    <a:t>OR &gt;1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F4B3EDC0-4576-1C9E-A0A4-EE586F50F751}"/>
                    </a:ext>
                  </a:extLst>
                </p:cNvPr>
                <p:cNvSpPr txBox="1"/>
                <p:nvPr/>
              </p:nvSpPr>
              <p:spPr>
                <a:xfrm rot="16200000">
                  <a:off x="145144" y="3599641"/>
                  <a:ext cx="710401" cy="29942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SE" sz="800" dirty="0">
                      <a:latin typeface="Helvetica" pitchFamily="2" charset="0"/>
                    </a:rPr>
                    <a:t>OR &lt;1</a:t>
                  </a:r>
                </a:p>
              </p:txBody>
            </p:sp>
          </p:grp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1343A44-9A07-F06C-BC54-AFA9E90EA9AE}"/>
                </a:ext>
              </a:extLst>
            </p:cNvPr>
            <p:cNvSpPr txBox="1"/>
            <p:nvPr/>
          </p:nvSpPr>
          <p:spPr>
            <a:xfrm>
              <a:off x="2048025" y="4388462"/>
              <a:ext cx="5565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800" dirty="0">
                  <a:latin typeface="Helvetica" pitchFamily="2" charset="0"/>
                </a:rPr>
                <a:t>No APN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6712607-111D-8B22-105A-48D262DF508E}"/>
                </a:ext>
              </a:extLst>
            </p:cNvPr>
            <p:cNvSpPr txBox="1"/>
            <p:nvPr/>
          </p:nvSpPr>
          <p:spPr>
            <a:xfrm>
              <a:off x="1279410" y="4385986"/>
              <a:ext cx="8483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800" dirty="0">
                  <a:latin typeface="Helvetica" pitchFamily="2" charset="0"/>
                </a:rPr>
                <a:t>Renal scarring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E0834585-5F86-470D-33A7-7F8BD6523710}"/>
                </a:ext>
              </a:extLst>
            </p:cNvPr>
            <p:cNvSpPr/>
            <p:nvPr/>
          </p:nvSpPr>
          <p:spPr>
            <a:xfrm>
              <a:off x="1317214" y="4459215"/>
              <a:ext cx="23037" cy="27101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 sz="800">
                <a:latin typeface="Helvetica" pitchFamily="2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5035839B-A372-27AA-0207-FC18ACB06322}"/>
                </a:ext>
              </a:extLst>
            </p:cNvPr>
            <p:cNvSpPr/>
            <p:nvPr/>
          </p:nvSpPr>
          <p:spPr>
            <a:xfrm>
              <a:off x="2064768" y="4457658"/>
              <a:ext cx="21158" cy="29341"/>
            </a:xfrm>
            <a:prstGeom prst="rect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 sz="800" dirty="0">
                <a:latin typeface="Helvetica" pitchFamily="2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1B2C57C-EB4D-2C5A-7421-F5273D29A3BE}"/>
                </a:ext>
              </a:extLst>
            </p:cNvPr>
            <p:cNvSpPr txBox="1"/>
            <p:nvPr/>
          </p:nvSpPr>
          <p:spPr>
            <a:xfrm>
              <a:off x="1451515" y="4233517"/>
              <a:ext cx="12688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E" sz="800" dirty="0">
                  <a:latin typeface="Helvetica" pitchFamily="2" charset="0"/>
                </a:rPr>
                <a:t>Representative SNPs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55FC2B4B-740A-8867-70C6-68583AC94971}"/>
              </a:ext>
            </a:extLst>
          </p:cNvPr>
          <p:cNvGrpSpPr/>
          <p:nvPr/>
        </p:nvGrpSpPr>
        <p:grpSpPr>
          <a:xfrm>
            <a:off x="4038137" y="5197641"/>
            <a:ext cx="709850" cy="504499"/>
            <a:chOff x="2233066" y="4758464"/>
            <a:chExt cx="709850" cy="504499"/>
          </a:xfrm>
        </p:grpSpPr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A2649243-AFB9-2042-214E-3022AD183ABF}"/>
                </a:ext>
              </a:extLst>
            </p:cNvPr>
            <p:cNvSpPr/>
            <p:nvPr/>
          </p:nvSpPr>
          <p:spPr>
            <a:xfrm>
              <a:off x="2233066" y="4818421"/>
              <a:ext cx="36856" cy="4726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 sz="800" dirty="0">
                <a:latin typeface="Helvetica" pitchFamily="2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2881B0EC-BC24-9642-0536-1C7C3609A3BA}"/>
                </a:ext>
              </a:extLst>
            </p:cNvPr>
            <p:cNvSpPr/>
            <p:nvPr/>
          </p:nvSpPr>
          <p:spPr>
            <a:xfrm>
              <a:off x="2233066" y="5010004"/>
              <a:ext cx="36856" cy="4726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 sz="800">
                <a:latin typeface="Helvetica" pitchFamily="2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4748F319-59E3-4165-C314-AF1C7FA15120}"/>
                </a:ext>
              </a:extLst>
            </p:cNvPr>
            <p:cNvSpPr/>
            <p:nvPr/>
          </p:nvSpPr>
          <p:spPr>
            <a:xfrm>
              <a:off x="2233066" y="4914213"/>
              <a:ext cx="36856" cy="47260"/>
            </a:xfrm>
            <a:prstGeom prst="rect">
              <a:avLst/>
            </a:prstGeom>
            <a:solidFill>
              <a:srgbClr val="1882C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 sz="800">
                <a:latin typeface="Helvetica" pitchFamily="2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9571832-248D-C0E8-CD9B-47D026A19EAB}"/>
                </a:ext>
              </a:extLst>
            </p:cNvPr>
            <p:cNvSpPr txBox="1"/>
            <p:nvPr/>
          </p:nvSpPr>
          <p:spPr>
            <a:xfrm>
              <a:off x="2285364" y="4758464"/>
              <a:ext cx="6575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800" dirty="0">
                  <a:latin typeface="Helvetica" pitchFamily="2" charset="0"/>
                </a:rPr>
                <a:t>HOM.REF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3194468-E4F4-0984-D7ED-380E79E645E1}"/>
                </a:ext>
              </a:extLst>
            </p:cNvPr>
            <p:cNvSpPr txBox="1"/>
            <p:nvPr/>
          </p:nvSpPr>
          <p:spPr>
            <a:xfrm>
              <a:off x="2285851" y="485690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800" dirty="0">
                  <a:latin typeface="Helvetica" pitchFamily="2" charset="0"/>
                </a:rPr>
                <a:t>HET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639B779-420A-CF9E-C3C0-C2B5AA1B995B}"/>
                </a:ext>
              </a:extLst>
            </p:cNvPr>
            <p:cNvSpPr txBox="1"/>
            <p:nvPr/>
          </p:nvSpPr>
          <p:spPr>
            <a:xfrm>
              <a:off x="2285362" y="4943746"/>
              <a:ext cx="6415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800" dirty="0">
                  <a:latin typeface="Helvetica" pitchFamily="2" charset="0"/>
                </a:rPr>
                <a:t>HOM.ALT</a:t>
              </a: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429A6179-F503-483C-1DCB-1C5A09DFF135}"/>
                </a:ext>
              </a:extLst>
            </p:cNvPr>
            <p:cNvSpPr/>
            <p:nvPr/>
          </p:nvSpPr>
          <p:spPr>
            <a:xfrm>
              <a:off x="2233066" y="5106257"/>
              <a:ext cx="36856" cy="4726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 sz="800">
                <a:latin typeface="Helvetica" pitchFamily="2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0473B0F-DC26-614C-36EA-833EA5BC72CD}"/>
                </a:ext>
              </a:extLst>
            </p:cNvPr>
            <p:cNvSpPr txBox="1"/>
            <p:nvPr/>
          </p:nvSpPr>
          <p:spPr>
            <a:xfrm>
              <a:off x="2285362" y="5047519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sz="800" dirty="0">
                  <a:latin typeface="Helvetica" pitchFamily="2" charset="0"/>
                </a:rPr>
                <a:t>MISS</a:t>
              </a: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6F80279C-38D6-D5C2-EAC6-69745A259739}"/>
              </a:ext>
            </a:extLst>
          </p:cNvPr>
          <p:cNvSpPr txBox="1"/>
          <p:nvPr/>
        </p:nvSpPr>
        <p:spPr>
          <a:xfrm>
            <a:off x="1726379" y="41950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14131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60</TotalTime>
  <Words>67</Words>
  <Application>Microsoft Macintosh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erese Rosenblad</dc:creator>
  <cp:lastModifiedBy>Gabriela Godaly</cp:lastModifiedBy>
  <cp:revision>24</cp:revision>
  <dcterms:created xsi:type="dcterms:W3CDTF">2024-01-30T14:12:26Z</dcterms:created>
  <dcterms:modified xsi:type="dcterms:W3CDTF">2024-04-23T15:22:40Z</dcterms:modified>
</cp:coreProperties>
</file>